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67" r:id="rId5"/>
  </p:sldIdLst>
  <p:sldSz cx="12192000" cy="6858000"/>
  <p:notesSz cx="7099300" cy="9385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oyun" initials="B" lastIdx="18" clrIdx="0">
    <p:extLst>
      <p:ext uri="{19B8F6BF-5375-455C-9EA6-DF929625EA0E}">
        <p15:presenceInfo xmlns:p15="http://schemas.microsoft.com/office/powerpoint/2012/main" userId="Jooyu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97" autoAdjust="0"/>
    <p:restoredTop sz="94004" autoAdjust="0"/>
  </p:normalViewPr>
  <p:slideViewPr>
    <p:cSldViewPr snapToGrid="0">
      <p:cViewPr varScale="1">
        <p:scale>
          <a:sx n="100" d="100"/>
          <a:sy n="100" d="100"/>
        </p:scale>
        <p:origin x="126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687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r">
              <a:defRPr sz="1200"/>
            </a:lvl1pPr>
          </a:lstStyle>
          <a:p>
            <a:fld id="{C566DA35-99F6-4000-9D74-43BC86A86EB4}" type="datetimeFigureOut">
              <a:rPr lang="en-US" smtClean="0"/>
              <a:t>11/11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29275" cy="3167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7" tIns="46218" rIns="92437" bIns="4621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73" y="4516356"/>
            <a:ext cx="5678154" cy="3695782"/>
          </a:xfrm>
          <a:prstGeom prst="rect">
            <a:avLst/>
          </a:prstGeom>
        </p:spPr>
        <p:txBody>
          <a:bodyPr vert="horz" lIns="92437" tIns="46218" rIns="92437" bIns="462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687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r">
              <a:defRPr sz="1200"/>
            </a:lvl1pPr>
          </a:lstStyle>
          <a:p>
            <a:fld id="{83825681-95D5-4F4F-B706-23D630D6045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048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F7DF-F4B6-4D27-875F-A91249D1D897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650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86CA-2504-4DC5-9AA8-360C101BFA4A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15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CBE2A-CA65-432F-B39E-6BE1012C3AD5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091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C468-719C-45E6-9651-86EE7BB74CCD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864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61A31-E71C-46E9-815E-037E5A45EC26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842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CB412-ABCB-4B5F-ACB6-42E1D6C2CD5A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87D8-3506-4D7A-9B56-CF00EE3F4E80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8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CC2AF-7287-47D5-9EBE-91894B4C09F4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324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9E61-3DB6-4BB8-B07A-61A55F1BCEBF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6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F5209-8CCC-438A-AD8E-713D8519690E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827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939DC-3D29-4751-9602-80C8C0CB46DD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560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C98A-7C6E-4F3C-811A-C11B3D3A9A34}" type="datetime1">
              <a:rPr lang="en-US" smtClean="0"/>
              <a:t>11/1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106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13" Type="http://schemas.openxmlformats.org/officeDocument/2006/relationships/image" Target="../media/image8.tif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tiff"/><Relationship Id="rId2" Type="http://schemas.openxmlformats.org/officeDocument/2006/relationships/image" Target="../media/image1.emf"/><Relationship Id="rId16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11" Type="http://schemas.openxmlformats.org/officeDocument/2006/relationships/image" Target="../media/image6.tif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0.tiff"/><Relationship Id="rId10" Type="http://schemas.openxmlformats.org/officeDocument/2006/relationships/image" Target="../media/image5.emf"/><Relationship Id="rId4" Type="http://schemas.openxmlformats.org/officeDocument/2006/relationships/image" Target="../media/image2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3B5BC5CC-F60A-4EC8-BD50-7C4AFF681DCF}"/>
              </a:ext>
            </a:extLst>
          </p:cNvPr>
          <p:cNvSpPr txBox="1"/>
          <p:nvPr/>
        </p:nvSpPr>
        <p:spPr>
          <a:xfrm>
            <a:off x="159797" y="5692722"/>
            <a:ext cx="11860567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Pharmacodynamic effects of TUS in MOLM14-luc cell model. A,  Percent orthotopically inoculated MOLM14-luc cells in marrow as a function of TUS dose. B, Plasma Inhibition Assay (PIA) documenting reduction of pFLT3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Y589/59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p-SYK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Y525/526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n MOLM-14 cells as a function of TUS dose. C-E, IHC analysis of p-FLT3, p-SYK, and p-ERK expression in marrow.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920323" y="234310"/>
            <a:ext cx="7914249" cy="5191250"/>
            <a:chOff x="1920323" y="234310"/>
            <a:chExt cx="7914249" cy="5191250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6E8D14A7-B407-4C72-B0A3-4EB47736E62E}"/>
                </a:ext>
              </a:extLst>
            </p:cNvPr>
            <p:cNvGrpSpPr/>
            <p:nvPr/>
          </p:nvGrpSpPr>
          <p:grpSpPr>
            <a:xfrm>
              <a:off x="1920323" y="234310"/>
              <a:ext cx="7914249" cy="5191250"/>
              <a:chOff x="1920323" y="399410"/>
              <a:chExt cx="7914249" cy="5191250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A8A54106-6221-46F0-90F8-AA0DC7970AE3}"/>
                  </a:ext>
                </a:extLst>
              </p:cNvPr>
              <p:cNvGrpSpPr/>
              <p:nvPr/>
            </p:nvGrpSpPr>
            <p:grpSpPr>
              <a:xfrm>
                <a:off x="5734762" y="399410"/>
                <a:ext cx="4099810" cy="2426297"/>
                <a:chOff x="5734762" y="399410"/>
                <a:chExt cx="4099810" cy="2426297"/>
              </a:xfrm>
            </p:grpSpPr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CA353E67-2455-4B19-90BD-0BC3171C06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734762" y="399410"/>
                  <a:ext cx="4099810" cy="2426297"/>
                </a:xfrm>
                <a:prstGeom prst="rect">
                  <a:avLst/>
                </a:prstGeom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6403031" y="607420"/>
                  <a:ext cx="3468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34098DC4-D849-416E-946E-FEC7596DF977}"/>
                  </a:ext>
                </a:extLst>
              </p:cNvPr>
              <p:cNvGrpSpPr/>
              <p:nvPr/>
            </p:nvGrpSpPr>
            <p:grpSpPr>
              <a:xfrm>
                <a:off x="1920323" y="607420"/>
                <a:ext cx="3597165" cy="2321571"/>
                <a:chOff x="1920323" y="607420"/>
                <a:chExt cx="3597165" cy="2321571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>
                  <a:off x="1920323" y="607420"/>
                  <a:ext cx="3468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graphicFrame>
              <p:nvGraphicFramePr>
                <p:cNvPr id="43" name="개체 4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609621765"/>
                    </p:ext>
                  </p:extLst>
                </p:nvPr>
              </p:nvGraphicFramePr>
              <p:xfrm>
                <a:off x="2090755" y="699965"/>
                <a:ext cx="3426733" cy="222902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" imgW="4671320" imgH="2805240" progId="Prism10.Document">
                        <p:embed/>
                      </p:oleObj>
                    </mc:Choice>
                    <mc:Fallback>
                      <p:oleObj name="Prism 10" r:id="rId3" imgW="4671320" imgH="2805240" progId="Prism10.Document">
                        <p:embed/>
                        <p:pic>
                          <p:nvPicPr>
                            <p:cNvPr id="43" name="개체 42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4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090755" y="699965"/>
                              <a:ext cx="3426733" cy="2229026"/>
                            </a:xfrm>
                            <a:prstGeom prst="rect">
                              <a:avLst/>
                            </a:prstGeom>
                            <a:noFill/>
                            <a:ln w="9525">
                              <a:noFill/>
                              <a:miter lim="800000"/>
                              <a:headEnd/>
                              <a:tailEnd/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A32BCFE9-572E-437C-81D3-4879ED9FF43E}"/>
                  </a:ext>
                </a:extLst>
              </p:cNvPr>
              <p:cNvGrpSpPr/>
              <p:nvPr/>
            </p:nvGrpSpPr>
            <p:grpSpPr>
              <a:xfrm>
                <a:off x="1935858" y="2886540"/>
                <a:ext cx="7578732" cy="2704120"/>
                <a:chOff x="1935858" y="3252226"/>
                <a:chExt cx="7578732" cy="2567036"/>
              </a:xfrm>
            </p:grpSpPr>
            <p:sp>
              <p:nvSpPr>
                <p:cNvPr id="7" name="TextBox 6"/>
                <p:cNvSpPr txBox="1"/>
                <p:nvPr/>
              </p:nvSpPr>
              <p:spPr>
                <a:xfrm>
                  <a:off x="1935858" y="3252226"/>
                  <a:ext cx="3468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graphicFrame>
              <p:nvGraphicFramePr>
                <p:cNvPr id="10" name="개체 9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192641581"/>
                    </p:ext>
                  </p:extLst>
                </p:nvPr>
              </p:nvGraphicFramePr>
              <p:xfrm>
                <a:off x="2276350" y="3511163"/>
                <a:ext cx="2200275" cy="141763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5" imgW="3928721" imgH="2590228" progId="Prism9.Document">
                        <p:embed/>
                      </p:oleObj>
                    </mc:Choice>
                    <mc:Fallback>
                      <p:oleObj name="Prism 9" r:id="rId5" imgW="3928721" imgH="2590228" progId="Prism9.Document">
                        <p:embed/>
                        <p:pic>
                          <p:nvPicPr>
                            <p:cNvPr id="10" name="개체 9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6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276350" y="3511163"/>
                              <a:ext cx="2200275" cy="1417637"/>
                            </a:xfrm>
                            <a:prstGeom prst="rect">
                              <a:avLst/>
                            </a:prstGeom>
                            <a:noFill/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3" name="개체 1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812177915"/>
                    </p:ext>
                  </p:extLst>
                </p:nvPr>
              </p:nvGraphicFramePr>
              <p:xfrm>
                <a:off x="4739594" y="3370835"/>
                <a:ext cx="2300287" cy="157003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7" imgW="3788628" imgH="2584465" progId="Prism9.Document">
                        <p:embed/>
                      </p:oleObj>
                    </mc:Choice>
                    <mc:Fallback>
                      <p:oleObj name="Prism 9" r:id="rId7" imgW="3788628" imgH="2584465" progId="Prism9.Document">
                        <p:embed/>
                        <p:pic>
                          <p:nvPicPr>
                            <p:cNvPr id="13" name="개체 12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8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739594" y="3370835"/>
                              <a:ext cx="2300287" cy="1570037"/>
                            </a:xfrm>
                            <a:prstGeom prst="rect">
                              <a:avLst/>
                            </a:prstGeom>
                            <a:noFill/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6" name="개체 15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938933266"/>
                    </p:ext>
                  </p:extLst>
                </p:nvPr>
              </p:nvGraphicFramePr>
              <p:xfrm>
                <a:off x="7225987" y="3357275"/>
                <a:ext cx="2244725" cy="159226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9" imgW="3940965" imgH="2777868" progId="Prism9.Document">
                        <p:embed/>
                      </p:oleObj>
                    </mc:Choice>
                    <mc:Fallback>
                      <p:oleObj name="Prism 9" r:id="rId9" imgW="3940965" imgH="2777868" progId="Prism9.Document">
                        <p:embed/>
                        <p:pic>
                          <p:nvPicPr>
                            <p:cNvPr id="16" name="개체 15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0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7225987" y="3357275"/>
                              <a:ext cx="2244725" cy="1592262"/>
                            </a:xfrm>
                            <a:prstGeom prst="rect">
                              <a:avLst/>
                            </a:prstGeom>
                            <a:noFill/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pic>
              <p:nvPicPr>
                <p:cNvPr id="44" name="그림 43"/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870" t="30408" r="23343" b="32929"/>
                <a:stretch/>
              </p:blipFill>
              <p:spPr>
                <a:xfrm>
                  <a:off x="3424009" y="5019183"/>
                  <a:ext cx="1116567" cy="800079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pic>
              <p:nvPicPr>
                <p:cNvPr id="48" name="그림 47"/>
                <p:cNvPicPr>
                  <a:picLocks noChangeAspect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" t="18168" r="63270" b="45169"/>
                <a:stretch/>
              </p:blipFill>
              <p:spPr>
                <a:xfrm>
                  <a:off x="2259127" y="5019183"/>
                  <a:ext cx="1117361" cy="788621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pic>
              <p:nvPicPr>
                <p:cNvPr id="49" name="그림 48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2" t="63781" r="62797"/>
                <a:stretch/>
              </p:blipFill>
              <p:spPr>
                <a:xfrm>
                  <a:off x="5894883" y="5014662"/>
                  <a:ext cx="1124678" cy="793365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pic>
              <p:nvPicPr>
                <p:cNvPr id="50" name="그림 49"/>
                <p:cNvPicPr>
                  <a:picLocks noChangeAspect="1"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378" r="22337" b="62772"/>
                <a:stretch/>
              </p:blipFill>
              <p:spPr>
                <a:xfrm>
                  <a:off x="4732505" y="5019183"/>
                  <a:ext cx="1120814" cy="784324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pic>
              <p:nvPicPr>
                <p:cNvPr id="51" name="그림 50"/>
                <p:cNvPicPr>
                  <a:picLocks noChangeAspect="1"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3193" t="45005" r="1713"/>
                <a:stretch/>
              </p:blipFill>
              <p:spPr>
                <a:xfrm>
                  <a:off x="7225987" y="5014885"/>
                  <a:ext cx="1117361" cy="788622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pic>
              <p:nvPicPr>
                <p:cNvPr id="52" name="그림 51"/>
                <p:cNvPicPr>
                  <a:picLocks noChangeAspect="1"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8" t="44789" r="44391"/>
                <a:stretch/>
              </p:blipFill>
              <p:spPr>
                <a:xfrm>
                  <a:off x="8392228" y="5021847"/>
                  <a:ext cx="1122362" cy="791731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</p:grpSp>
        </p:grpSp>
        <p:sp>
          <p:nvSpPr>
            <p:cNvPr id="22" name="TextBox 21"/>
            <p:cNvSpPr txBox="1"/>
            <p:nvPr/>
          </p:nvSpPr>
          <p:spPr>
            <a:xfrm>
              <a:off x="4413477" y="2729657"/>
              <a:ext cx="2962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879670" y="2721440"/>
              <a:ext cx="2962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86633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BF0FD5EBD9504A812482EA04CA64D6" ma:contentTypeVersion="17" ma:contentTypeDescription="Create a new document." ma:contentTypeScope="" ma:versionID="b5d29a2a6ada9cabbda7093401d8a1c2">
  <xsd:schema xmlns:xsd="http://www.w3.org/2001/XMLSchema" xmlns:xs="http://www.w3.org/2001/XMLSchema" xmlns:p="http://schemas.microsoft.com/office/2006/metadata/properties" xmlns:ns3="1eb8aacd-6de6-48dd-a465-60e446a07be9" xmlns:ns4="6c7c6a8e-e82f-4f57-8bcf-9b09f3980523" targetNamespace="http://schemas.microsoft.com/office/2006/metadata/properties" ma:root="true" ma:fieldsID="477d2955dc7cb3e9e420f794f0571505" ns3:_="" ns4:_="">
    <xsd:import namespace="1eb8aacd-6de6-48dd-a465-60e446a07be9"/>
    <xsd:import namespace="6c7c6a8e-e82f-4f57-8bcf-9b09f398052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b8aacd-6de6-48dd-a465-60e446a07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7c6a8e-e82f-4f57-8bcf-9b09f398052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b8aacd-6de6-48dd-a465-60e446a07be9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80DE6A3-5255-4AA5-B6DF-0755F693D23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b8aacd-6de6-48dd-a465-60e446a07be9"/>
    <ds:schemaRef ds:uri="6c7c6a8e-e82f-4f57-8bcf-9b09f3980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97F8308-BB12-4A2F-8FC0-9231D37CE5BB}">
  <ds:schemaRefs>
    <ds:schemaRef ds:uri="http://purl.org/dc/terms/"/>
    <ds:schemaRef ds:uri="http://schemas.openxmlformats.org/package/2006/metadata/core-properties"/>
    <ds:schemaRef ds:uri="1eb8aacd-6de6-48dd-a465-60e446a07be9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6c7c6a8e-e82f-4f57-8bcf-9b09f3980523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A905AD6D-FFB3-46D6-862B-6DD0C5991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40</TotalTime>
  <Words>73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owal, Himangshu</dc:creator>
  <cp:lastModifiedBy>Himangshu Sonowal</cp:lastModifiedBy>
  <cp:revision>819</cp:revision>
  <cp:lastPrinted>2024-09-20T16:49:30Z</cp:lastPrinted>
  <dcterms:created xsi:type="dcterms:W3CDTF">2023-07-11T20:23:00Z</dcterms:created>
  <dcterms:modified xsi:type="dcterms:W3CDTF">2024-11-12T02:13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BF0FD5EBD9504A812482EA04CA64D6</vt:lpwstr>
  </property>
</Properties>
</file>